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8" autoAdjust="0"/>
    <p:restoredTop sz="94660"/>
  </p:normalViewPr>
  <p:slideViewPr>
    <p:cSldViewPr snapToGrid="0">
      <p:cViewPr>
        <p:scale>
          <a:sx n="125" d="100"/>
          <a:sy n="125" d="100"/>
        </p:scale>
        <p:origin x="-1272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395C7-6601-419F-B9EA-7284DFC3FD1C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3EA92-1402-41F5-A1C6-5E8580E9F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1459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395C7-6601-419F-B9EA-7284DFC3FD1C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3EA92-1402-41F5-A1C6-5E8580E9F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95797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395C7-6601-419F-B9EA-7284DFC3FD1C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3EA92-1402-41F5-A1C6-5E8580E9F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5369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395C7-6601-419F-B9EA-7284DFC3FD1C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3EA92-1402-41F5-A1C6-5E8580E9F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73505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395C7-6601-419F-B9EA-7284DFC3FD1C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3EA92-1402-41F5-A1C6-5E8580E9F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9745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395C7-6601-419F-B9EA-7284DFC3FD1C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3EA92-1402-41F5-A1C6-5E8580E9F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3194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395C7-6601-419F-B9EA-7284DFC3FD1C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3EA92-1402-41F5-A1C6-5E8580E9F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93039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395C7-6601-419F-B9EA-7284DFC3FD1C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3EA92-1402-41F5-A1C6-5E8580E9F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8642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395C7-6601-419F-B9EA-7284DFC3FD1C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3EA92-1402-41F5-A1C6-5E8580E9F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607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395C7-6601-419F-B9EA-7284DFC3FD1C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3EA92-1402-41F5-A1C6-5E8580E9F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6498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395C7-6601-419F-B9EA-7284DFC3FD1C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53EA92-1402-41F5-A1C6-5E8580E9F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5021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0395C7-6601-419F-B9EA-7284DFC3FD1C}" type="datetimeFigureOut">
              <a:rPr kumimoji="1" lang="ja-JP" altLang="en-US" smtClean="0"/>
              <a:t>2019/9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53EA92-1402-41F5-A1C6-5E8580E9F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1200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9762" y="1538843"/>
            <a:ext cx="2946184" cy="2146349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78345" y="2263999"/>
            <a:ext cx="4793673" cy="1544030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739762" y="1338788"/>
            <a:ext cx="448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itchFamily="34" charset="0"/>
                <a:cs typeface="Arial" pitchFamily="34" charset="0"/>
              </a:rPr>
              <a:t>A</a:t>
            </a:r>
            <a:endParaRPr kumimoji="1" lang="ja-JP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4048502" y="1338788"/>
            <a:ext cx="4156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125DC0D9-FDF7-4D77-BA2E-FE69009169EF}"/>
              </a:ext>
            </a:extLst>
          </p:cNvPr>
          <p:cNvSpPr txBox="1"/>
          <p:nvPr/>
        </p:nvSpPr>
        <p:spPr>
          <a:xfrm>
            <a:off x="6175181" y="2263999"/>
            <a:ext cx="94958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125 </a:t>
            </a:r>
            <a:r>
              <a:rPr kumimoji="1" lang="en-US" altLang="ja-JP" sz="1400" dirty="0" err="1"/>
              <a:t>nM</a:t>
            </a:r>
            <a:endParaRPr kumimoji="1" lang="ja-JP" altLang="en-US" sz="14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F6D0029C-8992-44A5-BCB5-6D86A0BE822A}"/>
              </a:ext>
            </a:extLst>
          </p:cNvPr>
          <p:cNvSpPr txBox="1"/>
          <p:nvPr/>
        </p:nvSpPr>
        <p:spPr>
          <a:xfrm>
            <a:off x="4827965" y="2279239"/>
            <a:ext cx="94958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250 </a:t>
            </a:r>
            <a:r>
              <a:rPr kumimoji="1" lang="en-US" altLang="ja-JP" sz="1400" dirty="0" err="1"/>
              <a:t>nM</a:t>
            </a:r>
            <a:endParaRPr kumimoji="1" lang="ja-JP" altLang="en-US" sz="14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A27B9DB5-5DA1-41F6-9F2E-5BF194F5D026}"/>
              </a:ext>
            </a:extLst>
          </p:cNvPr>
          <p:cNvSpPr txBox="1"/>
          <p:nvPr/>
        </p:nvSpPr>
        <p:spPr>
          <a:xfrm>
            <a:off x="7443149" y="2270095"/>
            <a:ext cx="94958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50 </a:t>
            </a:r>
            <a:r>
              <a:rPr kumimoji="1" lang="en-US" altLang="ja-JP" sz="1400" dirty="0" err="1"/>
              <a:t>nM</a:t>
            </a:r>
            <a:endParaRPr kumimoji="1" lang="ja-JP" altLang="en-US" sz="14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528B80F4-6DFB-4101-AAF1-6CA38F713FA9}"/>
              </a:ext>
            </a:extLst>
          </p:cNvPr>
          <p:cNvSpPr txBox="1"/>
          <p:nvPr/>
        </p:nvSpPr>
        <p:spPr>
          <a:xfrm>
            <a:off x="954814" y="4411216"/>
            <a:ext cx="761720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Supplementary Fig. </a:t>
            </a:r>
            <a:r>
              <a:rPr lang="en-US" altLang="ja-JP" sz="1200" b="1" smtClean="0"/>
              <a:t>3.</a:t>
            </a:r>
            <a:r>
              <a:rPr lang="en-US" altLang="ja-JP" sz="1200" smtClean="0"/>
              <a:t> </a:t>
            </a:r>
            <a:r>
              <a:rPr lang="en-US" altLang="ja-JP" sz="1200" dirty="0"/>
              <a:t>Transfection conditions of </a:t>
            </a:r>
            <a:r>
              <a:rPr lang="en-US" altLang="ja-JP" sz="1200" i="1" dirty="0"/>
              <a:t>IMMT</a:t>
            </a:r>
            <a:r>
              <a:rPr lang="en-US" altLang="ja-JP" sz="1200" dirty="0"/>
              <a:t> siRNA. The IMMT protein was equally expressed in A549 and LC-2/ad cell lines based on western blot analysis (A). To investigate the role for IMMT, A549 cells were treated with IMMT siRNA. Among four IMMT siRNAs with different concentrations, siRNA #5 at 125 </a:t>
            </a:r>
            <a:r>
              <a:rPr lang="en-US" altLang="ja-JP" sz="1200" dirty="0" err="1"/>
              <a:t>nM</a:t>
            </a:r>
            <a:r>
              <a:rPr lang="en-US" altLang="ja-JP" sz="1200" dirty="0"/>
              <a:t> most effectively knocked down expression at the protein level (B). </a:t>
            </a:r>
            <a:endParaRPr lang="ja-JP" altLang="ja-JP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80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雄一</dc:creator>
  <cp:lastModifiedBy>007454</cp:lastModifiedBy>
  <cp:revision>3</cp:revision>
  <dcterms:created xsi:type="dcterms:W3CDTF">2019-03-27T13:11:48Z</dcterms:created>
  <dcterms:modified xsi:type="dcterms:W3CDTF">2019-09-04T06:25:58Z</dcterms:modified>
</cp:coreProperties>
</file>